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9" r:id="rId2"/>
    <p:sldId id="271" r:id="rId3"/>
    <p:sldId id="285" r:id="rId4"/>
    <p:sldId id="286" r:id="rId5"/>
    <p:sldId id="287" r:id="rId6"/>
    <p:sldId id="289" r:id="rId7"/>
    <p:sldId id="28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86452" autoAdjust="0"/>
  </p:normalViewPr>
  <p:slideViewPr>
    <p:cSldViewPr snapToGrid="0" showGuides="1">
      <p:cViewPr>
        <p:scale>
          <a:sx n="78" d="100"/>
          <a:sy n="78" d="100"/>
        </p:scale>
        <p:origin x="806" y="43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D7E2B3-12AD-40A8-A3CF-F88776C0DB27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4D2312-23CC-4EA8-BEB3-443C0C44D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61860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1: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Gene expression of KI67 in untreated vs peptide treated U2OS cells. 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Untreated and treated samples of GAPDH and Caspase 3 primers were run on an agarose (1.5%) gel.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Original unedited image of gel can be found in supplementary figure 7. (A) 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Expression of KI67 and GAPDH (indigenous control) in treated and untreated cells through gel electrophoresis.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(B)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Normalized expression of KI67 in untreated and treated cells </a:t>
            </a:r>
            <a:r>
              <a:rPr lang="en-US" dirty="0"/>
              <a:t>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*** P&lt; 0.0001, </a:t>
            </a:r>
            <a:r>
              <a:rPr lang="en-US" dirty="0"/>
              <a:t>n=4).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3A6DB4-8033-4A94-9156-BA97329F84F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14386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2: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Gene expression of </a:t>
            </a:r>
            <a:r>
              <a:rPr lang="en-US" sz="1200" b="1" i="0" u="none" strike="noStrike" baseline="0" dirty="0" err="1">
                <a:latin typeface="Times New Roman" panose="02020603050405020304" pitchFamily="18" charset="0"/>
              </a:rPr>
              <a:t>Survivin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 in U2OS cells. 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Untreated and treated samples of GAPDH and </a:t>
            </a:r>
            <a:r>
              <a:rPr lang="en-US" sz="1200" b="0" i="0" u="none" strike="noStrike" baseline="0" dirty="0" err="1">
                <a:latin typeface="Times New Roman" panose="02020603050405020304" pitchFamily="18" charset="0"/>
              </a:rPr>
              <a:t>Survivin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primers were run on an agarose (1.5%) gel.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Original unedited image of gel can be found in supplementary figure 7. 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(A) 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Gel electrophoresis </a:t>
            </a:r>
            <a:r>
              <a:rPr lang="en-US" sz="1200" b="0" i="0" u="none" strike="noStrike" baseline="0" dirty="0" err="1">
                <a:latin typeface="Times New Roman" panose="02020603050405020304" pitchFamily="18" charset="0"/>
              </a:rPr>
              <a:t>Survivin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and GAPDH (indigenous control) gene expression in untreated and peptide treated in cells. </a:t>
            </a:r>
            <a:r>
              <a:rPr lang="en-US" sz="1200" b="1" i="0" u="none" strike="noStrike" baseline="0" dirty="0">
                <a:latin typeface="Times New Roman" panose="02020603050405020304" pitchFamily="18" charset="0"/>
              </a:rPr>
              <a:t>(B)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Normalized expression of </a:t>
            </a:r>
            <a:r>
              <a:rPr lang="en-US" sz="1200" b="0" i="0" u="none" strike="noStrike" baseline="0" dirty="0" err="1">
                <a:latin typeface="Times New Roman" panose="02020603050405020304" pitchFamily="18" charset="0"/>
              </a:rPr>
              <a:t>Survivin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in untreated and treated cells. Treatment appeared to significantly decrease expression of </a:t>
            </a:r>
            <a:r>
              <a:rPr lang="en-US" sz="1200" b="0" i="0" u="none" strike="noStrike" baseline="0" dirty="0" err="1">
                <a:latin typeface="Times New Roman" panose="02020603050405020304" pitchFamily="18" charset="0"/>
              </a:rPr>
              <a:t>Survivin</a:t>
            </a:r>
            <a:r>
              <a:rPr lang="en-US" sz="1200" b="0" i="0" u="none" strike="noStrike" baseline="0" dirty="0">
                <a:latin typeface="Times New Roman" panose="02020603050405020304" pitchFamily="18" charset="0"/>
              </a:rPr>
              <a:t> </a:t>
            </a:r>
            <a:r>
              <a:rPr lang="en-US" dirty="0"/>
              <a:t>(</a:t>
            </a: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*** P&lt; 0.0001, </a:t>
            </a:r>
            <a:r>
              <a:rPr lang="en-US" dirty="0"/>
              <a:t>n=4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3A6DB4-8033-4A94-9156-BA97329F84F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70960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3: </a:t>
            </a:r>
            <a:r>
              <a:rPr lang="en-US" b="1" i="1" dirty="0"/>
              <a:t>S. aureus </a:t>
            </a:r>
            <a:r>
              <a:rPr lang="en-US" b="1" dirty="0"/>
              <a:t>cells under Scanning Electron Microscopy at two magnification powers. (A1) </a:t>
            </a:r>
            <a:r>
              <a:rPr lang="en-US" b="0" dirty="0"/>
              <a:t>P</a:t>
            </a:r>
            <a:r>
              <a:rPr lang="en-US" dirty="0"/>
              <a:t>eptide-treated cells at low magnification level. </a:t>
            </a:r>
            <a:r>
              <a:rPr lang="en-US" b="1" dirty="0"/>
              <a:t>(B1)</a:t>
            </a:r>
            <a:r>
              <a:rPr lang="en-US" dirty="0"/>
              <a:t> Ampicillin-treated cells at low magnification level</a:t>
            </a:r>
            <a:r>
              <a:rPr lang="en-US" b="0" dirty="0"/>
              <a:t>.</a:t>
            </a:r>
            <a:r>
              <a:rPr lang="en-US" b="1" dirty="0"/>
              <a:t> (C1) </a:t>
            </a:r>
            <a:r>
              <a:rPr lang="en-US" b="0" dirty="0"/>
              <a:t>Control cells at low magnification power. </a:t>
            </a:r>
            <a:r>
              <a:rPr lang="en-US" b="1" dirty="0"/>
              <a:t>(A2) </a:t>
            </a:r>
            <a:r>
              <a:rPr lang="en-US" b="0" dirty="0"/>
              <a:t>P</a:t>
            </a:r>
            <a:r>
              <a:rPr lang="en-US" dirty="0"/>
              <a:t>eptide-treated cells at higher magnification level. </a:t>
            </a:r>
            <a:r>
              <a:rPr lang="en-US" b="1" dirty="0"/>
              <a:t>(B2)</a:t>
            </a:r>
            <a:r>
              <a:rPr lang="en-US" dirty="0"/>
              <a:t> Ampicillin-treated cells at higher magnification level</a:t>
            </a:r>
            <a:r>
              <a:rPr lang="en-US" b="0" dirty="0"/>
              <a:t>.</a:t>
            </a:r>
            <a:r>
              <a:rPr lang="en-US" b="1" dirty="0"/>
              <a:t> (C2) </a:t>
            </a:r>
            <a:r>
              <a:rPr lang="en-US" b="0" dirty="0"/>
              <a:t>Control cells at higher magnification power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53A6DB4-8033-4A94-9156-BA97329F84F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9985854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4: </a:t>
            </a:r>
            <a:r>
              <a:rPr lang="en-US" b="1" i="1" dirty="0"/>
              <a:t>E. coli </a:t>
            </a:r>
            <a:r>
              <a:rPr lang="en-US" b="1" dirty="0"/>
              <a:t>cells under Scanning Electron Microscopy at two magnification powers. (A1) </a:t>
            </a:r>
            <a:r>
              <a:rPr lang="en-US" b="0" dirty="0"/>
              <a:t>P</a:t>
            </a:r>
            <a:r>
              <a:rPr lang="en-US" dirty="0"/>
              <a:t>eptide-treated cells at low magnification level. </a:t>
            </a:r>
            <a:r>
              <a:rPr lang="en-US" b="1" dirty="0"/>
              <a:t>(B1)</a:t>
            </a:r>
            <a:r>
              <a:rPr lang="en-US" dirty="0"/>
              <a:t> Ampicillin-treated cells at low magnification level</a:t>
            </a:r>
            <a:r>
              <a:rPr lang="en-US" b="0" dirty="0"/>
              <a:t>. </a:t>
            </a:r>
            <a:r>
              <a:rPr lang="en-US" b="1" dirty="0"/>
              <a:t>(A2) </a:t>
            </a:r>
            <a:r>
              <a:rPr lang="en-US" b="0" dirty="0"/>
              <a:t>P</a:t>
            </a:r>
            <a:r>
              <a:rPr lang="en-US" dirty="0"/>
              <a:t>eptide-treated cells at higher magnification level. </a:t>
            </a:r>
            <a:r>
              <a:rPr lang="en-US" b="1" dirty="0"/>
              <a:t>(B2)</a:t>
            </a:r>
            <a:r>
              <a:rPr lang="en-US" dirty="0"/>
              <a:t> Ampicillin-treated cells at higher magnification level</a:t>
            </a:r>
            <a:r>
              <a:rPr lang="en-US" b="0" dirty="0"/>
              <a:t>.</a:t>
            </a:r>
            <a:r>
              <a:rPr lang="en-US" b="1" dirty="0"/>
              <a:t> (C) </a:t>
            </a:r>
            <a:r>
              <a:rPr lang="en-US" b="0" dirty="0"/>
              <a:t>Control cells.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53A6DB4-8033-4A94-9156-BA97329F84FB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4200589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ure 5: Agarose gel (1.5%) electrophoresis of untreated and treated samples with Caspase 3 and B-actin primer gene expression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D2312-23CC-4EA8-BEB3-443C0C44D08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117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6: Nitrocellulose membrane of PARP-1 cleaved, PARP-1 </a:t>
            </a:r>
            <a:r>
              <a:rPr lang="en-US" b="1" dirty="0" err="1"/>
              <a:t>uncleaved</a:t>
            </a:r>
            <a:r>
              <a:rPr lang="en-US" b="1" dirty="0"/>
              <a:t>, and GAPDH protein expression. (A) Captured image of membrane via transilluminator. (B) White tray image of membrane expression. (C) Captured image of membrane with black tray background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D2312-23CC-4EA8-BEB3-443C0C44D084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87381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Supplementary Figure 7: Agarose gel electrophoresis of untreated and treated samples with KI67, </a:t>
            </a:r>
            <a:r>
              <a:rPr lang="en-US" b="1" dirty="0" err="1"/>
              <a:t>Survivin</a:t>
            </a:r>
            <a:r>
              <a:rPr lang="en-US" b="1" dirty="0"/>
              <a:t>, B-actin primer gene expression. (A) Ethidium bromide UV image of gels with samples expressing KI67 and </a:t>
            </a:r>
            <a:r>
              <a:rPr lang="en-US" b="1" dirty="0" err="1"/>
              <a:t>Survivin</a:t>
            </a:r>
            <a:r>
              <a:rPr lang="en-US" b="1" dirty="0"/>
              <a:t> primers (B) Gel images of GAPDH expression of untreated cell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64D2312-23CC-4EA8-BEB3-443C0C44D084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473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38E36-FD00-9086-334A-C70DB748A6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BBEF802-7EC7-F799-C5A9-A8B5A48A966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D0EF50-B654-7B4B-7CA3-805A4E22A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AF5A55-2644-6E43-B0AF-E7CA50FE7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BFEB79-39C9-012A-414D-F6BBC9E09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959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FFC929-FA36-D71C-9E7E-66F84549B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6CE34B-876C-445A-2CBD-34E4C9132D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A04D9A-CEE0-9AA4-E99E-6886763C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E3A472-DCEA-DE48-C2C5-324757057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088C71-0114-A44B-5EFA-8EF2701A6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28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7AB286-6F2A-BA81-96C5-6F9E513BA75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DDCD0A-CE66-5DAE-3AE1-1828C6C15D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5389B7-26DB-D8E0-5CAD-FE8998D013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AB3FA3-36C1-FF27-0A87-A87F93A94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F6725F-BD15-8269-98BB-EAE429523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8083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48EB8B-8BC1-C1A9-042B-9D11B72DBC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138BC4-A03A-7F34-1AE1-868123146EA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AC9593-7103-26EC-2831-D705160C37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EB3581-EC74-0E19-CFFF-AFE8996B3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EADC9-1877-61B4-A510-868AEC01D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04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E7B5CA-4460-4947-3469-1C940A6E31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562E1B-2301-1C1A-0370-7B0BFFD608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4A77EE-B315-E6C3-521B-C18DB4456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FD99D9-CF12-EF0A-AAA9-F51C8691A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8FA085-7E21-D6FD-C827-54EB032A2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2600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8525A9-AF77-2862-360D-7FD0310757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3D7AEF-C614-BDE6-77FE-3F4CB060E2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810C54-6902-898B-6967-DE8BC29F56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D2850F4-3B66-099D-353E-2A06EA8724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98607E-0E30-CFB2-04B3-5BD6F49E45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3874D9-AF30-4E98-D5A7-37E3DEDF3D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475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6431D4-441F-EEA7-90D5-BADC745C09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A5470D-CB31-B5DD-E529-94F6C9B480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C85850-9D69-202C-7313-A3CCF70C8D3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E14144-051D-F2F2-2812-EE910464A1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2299B3F-E447-121C-BA76-C84CEC45FB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DAF98B0-1DAE-AF4B-7444-9471227014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A8A163-3298-76EE-2CB4-584AC5968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7F5A7D0-C501-645F-E032-F8DDF81217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573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0A85A4-9DE8-6FDE-49AD-FDDEC99660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BE0AD3-4E13-2606-F3EB-9D0B77669D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9CBD7C-9C9F-5F5F-8649-4377089F9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9C6E080-FB95-E9D2-C6E4-163B4B9949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633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6510EB-A136-EC3D-CF86-141B37713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665B3-93A3-818D-50FC-848769F382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E280C15-C844-1671-F1AF-0C6CC79005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489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5CA017-0414-984E-2C0D-EBF98DF8A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F1C51A-E0CB-37B0-EA61-4967C9865D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BB9614-9E50-D597-2842-6804DF7201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F3CA97-5E5C-F426-6D60-D67C487424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D54510-8A72-3AAF-9786-63DDA5657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A8E393-63AC-5BA9-DBFC-89A1E10257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788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F17371-906D-B037-7A10-B4D2A521E8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2F24F5-1906-5348-F4F2-3A4BBDFCC14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62FF00-B130-FBC8-F539-2F4F195A3D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DB30A9-657E-C232-331C-B9AA98078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6174D2-9EFB-3243-BE6A-4C2362883D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86E82C-5C7B-0A01-5B73-5408E5BE0A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64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10ADEAB-28F5-C5B7-AF93-55287CFB37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06C84B-F3F5-B90C-382E-5BF125B351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6E3019-6EF3-11F6-B47F-4811508723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D3F157-B9DC-4334-8553-52CA43898C5E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C0DFF0-5609-6E49-B3FC-EF634013F7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74D44E-B949-D6B5-5E53-234A0D9521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AD4C77-6DAC-4213-BBFD-494B380E1E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9212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2.png"/><Relationship Id="rId10" Type="http://schemas.openxmlformats.org/officeDocument/2006/relationships/image" Target="../media/image5.tif"/><Relationship Id="rId4" Type="http://schemas.openxmlformats.org/officeDocument/2006/relationships/image" Target="../media/image1.emf"/><Relationship Id="rId9" Type="http://schemas.microsoft.com/office/2007/relationships/hdphoto" Target="../media/hdphoto2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oleObject" Target="../embeddings/oleObject2.bin"/><Relationship Id="rId7" Type="http://schemas.openxmlformats.org/officeDocument/2006/relationships/image" Target="../media/image9.ti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tif"/><Relationship Id="rId5" Type="http://schemas.openxmlformats.org/officeDocument/2006/relationships/image" Target="../media/image7.tif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i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064366B5-7032-48F4-8A16-89C5D09F8B0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541407" y="1722973"/>
          <a:ext cx="3441700" cy="30781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3442243" imgH="3078032" progId="Prism7.Document">
                  <p:embed/>
                </p:oleObj>
              </mc:Choice>
              <mc:Fallback>
                <p:oleObj name="Prism 7" r:id="rId3" imgW="3442243" imgH="3078032" progId="Prism7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064366B5-7032-48F4-8A16-89C5D09F8B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541407" y="1722973"/>
                        <a:ext cx="3441700" cy="30781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2411552-5548-41DE-B6BE-888F6C279FD8}"/>
              </a:ext>
            </a:extLst>
          </p:cNvPr>
          <p:cNvSpPr txBox="1"/>
          <p:nvPr/>
        </p:nvSpPr>
        <p:spPr>
          <a:xfrm>
            <a:off x="2727317" y="2241937"/>
            <a:ext cx="496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AA208C-49AC-4C7B-BAD6-C7DF977A194D}"/>
              </a:ext>
            </a:extLst>
          </p:cNvPr>
          <p:cNvSpPr txBox="1"/>
          <p:nvPr/>
        </p:nvSpPr>
        <p:spPr>
          <a:xfrm>
            <a:off x="6096000" y="2241937"/>
            <a:ext cx="496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7C1A99-7CB5-4D96-9AE9-4B649967D941}"/>
              </a:ext>
            </a:extLst>
          </p:cNvPr>
          <p:cNvSpPr txBox="1"/>
          <p:nvPr/>
        </p:nvSpPr>
        <p:spPr>
          <a:xfrm>
            <a:off x="3395302" y="2418166"/>
            <a:ext cx="1207504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Untreated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5FBAB10-EFC4-427C-8F52-5F890E23B95D}"/>
              </a:ext>
            </a:extLst>
          </p:cNvPr>
          <p:cNvSpPr txBox="1"/>
          <p:nvPr/>
        </p:nvSpPr>
        <p:spPr>
          <a:xfrm>
            <a:off x="2550363" y="3704438"/>
            <a:ext cx="888773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KI67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E46D43C-634A-4C63-9A17-71FC6D3E5546}"/>
              </a:ext>
            </a:extLst>
          </p:cNvPr>
          <p:cNvSpPr txBox="1"/>
          <p:nvPr/>
        </p:nvSpPr>
        <p:spPr>
          <a:xfrm>
            <a:off x="2550363" y="2820645"/>
            <a:ext cx="963936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F2DC3C-7AC7-4E9D-9270-15BB931F4F76}"/>
              </a:ext>
            </a:extLst>
          </p:cNvPr>
          <p:cNvSpPr txBox="1"/>
          <p:nvPr/>
        </p:nvSpPr>
        <p:spPr>
          <a:xfrm>
            <a:off x="4839000" y="2418166"/>
            <a:ext cx="876980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reated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2C28121-D0B7-CB19-4D3F-6358CED57994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453" y="2787559"/>
            <a:ext cx="960120" cy="36576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A53A59F6-B19C-8CB9-BCF9-D9DB146FBD82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2094" y="3671352"/>
            <a:ext cx="960120" cy="36576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4E35EE03-B91C-BE5A-2C54-D5BDF2FDA56A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2094" y="2787559"/>
            <a:ext cx="960120" cy="3657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7275EC2-BF0E-9323-7A80-9B155D19E992}"/>
              </a:ext>
            </a:extLst>
          </p:cNvPr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6453" y="3671352"/>
            <a:ext cx="960120" cy="36576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F8B7274-773E-2F63-BB9D-D5216E1E6312}"/>
              </a:ext>
            </a:extLst>
          </p:cNvPr>
          <p:cNvSpPr txBox="1"/>
          <p:nvPr/>
        </p:nvSpPr>
        <p:spPr>
          <a:xfrm>
            <a:off x="3395302" y="3336193"/>
            <a:ext cx="1207504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Untreated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1D23FDB-6A16-D1B7-0E9F-9D379C66637A}"/>
              </a:ext>
            </a:extLst>
          </p:cNvPr>
          <p:cNvSpPr txBox="1"/>
          <p:nvPr/>
        </p:nvSpPr>
        <p:spPr>
          <a:xfrm>
            <a:off x="4839000" y="3336193"/>
            <a:ext cx="876980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reated </a:t>
            </a:r>
          </a:p>
        </p:txBody>
      </p:sp>
    </p:spTree>
    <p:extLst>
      <p:ext uri="{BB962C8B-B14F-4D97-AF65-F5344CB8AC3E}">
        <p14:creationId xmlns:p14="http://schemas.microsoft.com/office/powerpoint/2010/main" val="8761951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40983C63-3C8B-47EF-B5E0-FEE4FE6717F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459993" y="1675241"/>
          <a:ext cx="3341687" cy="3128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7" r:id="rId3" imgW="3341816" imgH="3128426" progId="Prism7.Document">
                  <p:embed/>
                </p:oleObj>
              </mc:Choice>
              <mc:Fallback>
                <p:oleObj name="Prism 7" r:id="rId3" imgW="3341816" imgH="3128426" progId="Prism7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40983C63-3C8B-47EF-B5E0-FEE4FE6717F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459993" y="1675241"/>
                        <a:ext cx="3341687" cy="31289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Box 13">
            <a:extLst>
              <a:ext uri="{FF2B5EF4-FFF2-40B4-BE49-F238E27FC236}">
                <a16:creationId xmlns:a16="http://schemas.microsoft.com/office/drawing/2014/main" id="{AD28FC02-5CB0-4A3D-84FE-2A509C29ACC9}"/>
              </a:ext>
            </a:extLst>
          </p:cNvPr>
          <p:cNvSpPr txBox="1"/>
          <p:nvPr/>
        </p:nvSpPr>
        <p:spPr>
          <a:xfrm>
            <a:off x="2727317" y="2241937"/>
            <a:ext cx="496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4E32965-67EC-4D50-8677-1577842954A6}"/>
              </a:ext>
            </a:extLst>
          </p:cNvPr>
          <p:cNvSpPr txBox="1"/>
          <p:nvPr/>
        </p:nvSpPr>
        <p:spPr>
          <a:xfrm>
            <a:off x="6096000" y="2241937"/>
            <a:ext cx="4960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B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807053C-A7AC-43C8-B795-FC59E63900FA}"/>
              </a:ext>
            </a:extLst>
          </p:cNvPr>
          <p:cNvSpPr txBox="1"/>
          <p:nvPr/>
        </p:nvSpPr>
        <p:spPr>
          <a:xfrm>
            <a:off x="3570897" y="2473279"/>
            <a:ext cx="1207505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Untreated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6149A66-CE18-4EDA-A772-E5B85E16941C}"/>
              </a:ext>
            </a:extLst>
          </p:cNvPr>
          <p:cNvSpPr txBox="1"/>
          <p:nvPr/>
        </p:nvSpPr>
        <p:spPr>
          <a:xfrm>
            <a:off x="2727317" y="3741575"/>
            <a:ext cx="8887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/>
              <a:t>Survivin</a:t>
            </a:r>
            <a:endParaRPr lang="en-US" sz="16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57C315-F09B-43A1-BAAC-4E0FD7BFF211}"/>
              </a:ext>
            </a:extLst>
          </p:cNvPr>
          <p:cNvSpPr txBox="1"/>
          <p:nvPr/>
        </p:nvSpPr>
        <p:spPr>
          <a:xfrm>
            <a:off x="2796010" y="2791719"/>
            <a:ext cx="963936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D3111F-D889-45EB-B717-D78B15074206}"/>
              </a:ext>
            </a:extLst>
          </p:cNvPr>
          <p:cNvSpPr txBox="1"/>
          <p:nvPr/>
        </p:nvSpPr>
        <p:spPr>
          <a:xfrm>
            <a:off x="4971979" y="2473279"/>
            <a:ext cx="876980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reated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67B5A6B-5194-B35D-0B8A-D87B1DBDEA90}"/>
              </a:ext>
            </a:extLst>
          </p:cNvPr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066" y="2800102"/>
            <a:ext cx="960120" cy="36576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D0D2C15-F856-CFDC-757D-051ADB5DAFE5}"/>
              </a:ext>
            </a:extLst>
          </p:cNvPr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8656" y="2837322"/>
            <a:ext cx="960120" cy="36576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77B8EF3-A56D-6017-4BD7-C8AE9D512D16}"/>
              </a:ext>
            </a:extLst>
          </p:cNvPr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8656" y="3739340"/>
            <a:ext cx="960120" cy="36576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2ED18548-65B1-88D3-4A35-E1A6BFB97BE1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5060" y="3739340"/>
            <a:ext cx="960120" cy="36576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D320290-8123-BD90-8D46-4410FC7FC4D5}"/>
              </a:ext>
            </a:extLst>
          </p:cNvPr>
          <p:cNvSpPr txBox="1"/>
          <p:nvPr/>
        </p:nvSpPr>
        <p:spPr>
          <a:xfrm>
            <a:off x="3570897" y="3414781"/>
            <a:ext cx="1207505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Untreated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D5F52E8-17D7-3CFC-AFBE-4D31068E8311}"/>
              </a:ext>
            </a:extLst>
          </p:cNvPr>
          <p:cNvSpPr txBox="1"/>
          <p:nvPr/>
        </p:nvSpPr>
        <p:spPr>
          <a:xfrm>
            <a:off x="4971979" y="3414781"/>
            <a:ext cx="876980" cy="2995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reated </a:t>
            </a:r>
          </a:p>
        </p:txBody>
      </p:sp>
    </p:spTree>
    <p:extLst>
      <p:ext uri="{BB962C8B-B14F-4D97-AF65-F5344CB8AC3E}">
        <p14:creationId xmlns:p14="http://schemas.microsoft.com/office/powerpoint/2010/main" val="2039334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226DD56-09A2-0579-F994-6A4C50928E9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6254" y="4598605"/>
            <a:ext cx="3080068" cy="2215826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0879048-5FC1-4122-543A-0BD34B784C8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6723" y="46867"/>
            <a:ext cx="3075772" cy="2212529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1BBE756-5241-823E-E0D4-9326CEB519A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6254" y="2346580"/>
            <a:ext cx="3070617" cy="2208409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0D4CA6A-96A4-CBA7-9504-DEB3EBA0D03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2996" y="41922"/>
            <a:ext cx="3082645" cy="2217474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F89C16A-9E15-632E-D1C9-BE0EA11BA34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2996" y="2312363"/>
            <a:ext cx="3073195" cy="2210058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70B71EB-14CB-3319-2098-68E085250E23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0180" y="4575388"/>
            <a:ext cx="3046561" cy="2191105"/>
          </a:xfrm>
          <a:prstGeom prst="rect">
            <a:avLst/>
          </a:prstGeom>
          <a:noFill/>
          <a:ln>
            <a:noFill/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C0AFC4F6-C5C0-6FB7-5C73-E58AC41ECC15}"/>
              </a:ext>
            </a:extLst>
          </p:cNvPr>
          <p:cNvSpPr txBox="1"/>
          <p:nvPr/>
        </p:nvSpPr>
        <p:spPr>
          <a:xfrm>
            <a:off x="2717404" y="41922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1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9CD115-4863-2E50-A934-3FC5E2B569E2}"/>
              </a:ext>
            </a:extLst>
          </p:cNvPr>
          <p:cNvSpPr txBox="1"/>
          <p:nvPr/>
        </p:nvSpPr>
        <p:spPr>
          <a:xfrm>
            <a:off x="2744665" y="2308655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1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FD52E77-CA3F-6D95-63AE-E5E3203398E2}"/>
              </a:ext>
            </a:extLst>
          </p:cNvPr>
          <p:cNvSpPr txBox="1"/>
          <p:nvPr/>
        </p:nvSpPr>
        <p:spPr>
          <a:xfrm>
            <a:off x="2744665" y="4575388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C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6D5D06-062C-8CCB-AE9B-02B7320A8C93}"/>
              </a:ext>
            </a:extLst>
          </p:cNvPr>
          <p:cNvSpPr txBox="1"/>
          <p:nvPr/>
        </p:nvSpPr>
        <p:spPr>
          <a:xfrm>
            <a:off x="6442370" y="41922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2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7B337B3-E634-F3C1-722F-4A75CADB4107}"/>
              </a:ext>
            </a:extLst>
          </p:cNvPr>
          <p:cNvSpPr txBox="1"/>
          <p:nvPr/>
        </p:nvSpPr>
        <p:spPr>
          <a:xfrm>
            <a:off x="6467620" y="2343683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2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CAA2B4E-4B6E-7361-6F22-A17F5710BB13}"/>
              </a:ext>
            </a:extLst>
          </p:cNvPr>
          <p:cNvSpPr txBox="1"/>
          <p:nvPr/>
        </p:nvSpPr>
        <p:spPr>
          <a:xfrm>
            <a:off x="6467620" y="4595832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C2)</a:t>
            </a:r>
          </a:p>
        </p:txBody>
      </p:sp>
    </p:spTree>
    <p:extLst>
      <p:ext uri="{BB962C8B-B14F-4D97-AF65-F5344CB8AC3E}">
        <p14:creationId xmlns:p14="http://schemas.microsoft.com/office/powerpoint/2010/main" val="21225179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17697BC-0486-7D9A-3218-118B382C238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6382" y="124056"/>
            <a:ext cx="2980527" cy="2234982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BE6278F9-D27E-6E18-701C-1B6D94EF9949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0555" y="116204"/>
            <a:ext cx="3002018" cy="2250687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D3C0350E-6532-178D-4AAA-F5387B3F3BC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6382" y="2440536"/>
            <a:ext cx="2987966" cy="2242421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0CAA8AC-425F-0763-7C87-E976D831999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79729" y="2429791"/>
            <a:ext cx="3002844" cy="2253166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9EB704A-01A0-8C6B-CDE7-B72CBBDA358D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6382" y="4737590"/>
            <a:ext cx="3008630" cy="2082800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17FFB6C-627B-EFCC-7F06-33970EF8F134}"/>
              </a:ext>
            </a:extLst>
          </p:cNvPr>
          <p:cNvSpPr txBox="1"/>
          <p:nvPr/>
        </p:nvSpPr>
        <p:spPr>
          <a:xfrm>
            <a:off x="2884966" y="121831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1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C4AC5C4-F4DE-1D2C-436D-6B731E6BB018}"/>
              </a:ext>
            </a:extLst>
          </p:cNvPr>
          <p:cNvSpPr txBox="1"/>
          <p:nvPr/>
        </p:nvSpPr>
        <p:spPr>
          <a:xfrm>
            <a:off x="2884966" y="2435163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1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733359-62D3-78CC-724A-E66BA74F7356}"/>
              </a:ext>
            </a:extLst>
          </p:cNvPr>
          <p:cNvSpPr txBox="1"/>
          <p:nvPr/>
        </p:nvSpPr>
        <p:spPr>
          <a:xfrm>
            <a:off x="6452530" y="121831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2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D340EE9-3FCA-07D8-6ACC-FCA5E7A9B44D}"/>
              </a:ext>
            </a:extLst>
          </p:cNvPr>
          <p:cNvSpPr txBox="1"/>
          <p:nvPr/>
        </p:nvSpPr>
        <p:spPr>
          <a:xfrm>
            <a:off x="6452530" y="2435163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2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B928F05-DB61-8A52-CD11-3E932E3892AD}"/>
              </a:ext>
            </a:extLst>
          </p:cNvPr>
          <p:cNvSpPr txBox="1"/>
          <p:nvPr/>
        </p:nvSpPr>
        <p:spPr>
          <a:xfrm>
            <a:off x="2985324" y="4726439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28364198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black and white image of a building&#10;&#10;Description automatically generated">
            <a:extLst>
              <a:ext uri="{FF2B5EF4-FFF2-40B4-BE49-F238E27FC236}">
                <a16:creationId xmlns:a16="http://schemas.microsoft.com/office/drawing/2014/main" id="{B4C33584-0BD9-09D9-599B-76095F64518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2568" y="1764610"/>
            <a:ext cx="8526864" cy="4351338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FA831E9-30FF-B80B-D325-CF65328AC8B5}"/>
              </a:ext>
            </a:extLst>
          </p:cNvPr>
          <p:cNvSpPr txBox="1"/>
          <p:nvPr/>
        </p:nvSpPr>
        <p:spPr>
          <a:xfrm rot="18815474">
            <a:off x="3514976" y="754059"/>
            <a:ext cx="24513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Caspase 3 Sample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A56661E-39A8-E7D5-1ACA-F29B60C144E9}"/>
              </a:ext>
            </a:extLst>
          </p:cNvPr>
          <p:cNvSpPr txBox="1"/>
          <p:nvPr/>
        </p:nvSpPr>
        <p:spPr>
          <a:xfrm rot="18815474">
            <a:off x="3965865" y="720349"/>
            <a:ext cx="2460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Treated Caspase 3 Sample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ABF0EBA-58F5-E085-EF3A-EE56FF301CC5}"/>
              </a:ext>
            </a:extLst>
          </p:cNvPr>
          <p:cNvSpPr txBox="1"/>
          <p:nvPr/>
        </p:nvSpPr>
        <p:spPr>
          <a:xfrm rot="18815474">
            <a:off x="4339667" y="617142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B-actin Sampl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CBA509-8E6D-1071-D7CE-059849E48BD0}"/>
              </a:ext>
            </a:extLst>
          </p:cNvPr>
          <p:cNvSpPr txBox="1"/>
          <p:nvPr/>
        </p:nvSpPr>
        <p:spPr>
          <a:xfrm rot="18815474">
            <a:off x="5219995" y="1064287"/>
            <a:ext cx="1477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ad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C7E5C6-5311-685B-581E-2D2ED045A5E8}"/>
              </a:ext>
            </a:extLst>
          </p:cNvPr>
          <p:cNvSpPr txBox="1"/>
          <p:nvPr/>
        </p:nvSpPr>
        <p:spPr>
          <a:xfrm rot="18815474">
            <a:off x="4669082" y="623111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Treated B-actin Sample </a:t>
            </a:r>
          </a:p>
        </p:txBody>
      </p:sp>
    </p:spTree>
    <p:extLst>
      <p:ext uri="{BB962C8B-B14F-4D97-AF65-F5344CB8AC3E}">
        <p14:creationId xmlns:p14="http://schemas.microsoft.com/office/powerpoint/2010/main" val="8123593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>
            <a:extLst>
              <a:ext uri="{FF2B5EF4-FFF2-40B4-BE49-F238E27FC236}">
                <a16:creationId xmlns:a16="http://schemas.microsoft.com/office/drawing/2014/main" id="{87365766-99BE-4E2B-E920-E1DFEC2B227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43" t="27679" r="48035" b="31914"/>
          <a:stretch/>
        </p:blipFill>
        <p:spPr bwMode="auto">
          <a:xfrm rot="16200000" flipH="1" flipV="1">
            <a:off x="4553267" y="-405637"/>
            <a:ext cx="1685300" cy="31209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41B37763-05B4-032F-7986-08A3D505670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8" b="36077"/>
          <a:stretch/>
        </p:blipFill>
        <p:spPr bwMode="auto">
          <a:xfrm>
            <a:off x="3833817" y="2229489"/>
            <a:ext cx="3124200" cy="94399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6397ABF-B6BE-AA88-636B-4D019F92DBE8}"/>
              </a:ext>
            </a:extLst>
          </p:cNvPr>
          <p:cNvSpPr txBox="1"/>
          <p:nvPr/>
        </p:nvSpPr>
        <p:spPr>
          <a:xfrm>
            <a:off x="7034217" y="2252513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5 KD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987E90-3D45-2507-8BEE-97D74D80EDF4}"/>
              </a:ext>
            </a:extLst>
          </p:cNvPr>
          <p:cNvSpPr txBox="1"/>
          <p:nvPr/>
        </p:nvSpPr>
        <p:spPr>
          <a:xfrm>
            <a:off x="7034217" y="501122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16 K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FCF16A4-D996-9122-81E6-A62BB41C052F}"/>
              </a:ext>
            </a:extLst>
          </p:cNvPr>
          <p:cNvSpPr txBox="1"/>
          <p:nvPr/>
        </p:nvSpPr>
        <p:spPr>
          <a:xfrm>
            <a:off x="7034217" y="1483885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9 K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BBEF5CE-E764-50FF-58EF-F24B51A755AB}"/>
              </a:ext>
            </a:extLst>
          </p:cNvPr>
          <p:cNvSpPr txBox="1"/>
          <p:nvPr/>
        </p:nvSpPr>
        <p:spPr>
          <a:xfrm>
            <a:off x="3922209" y="-74836"/>
            <a:ext cx="2971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reated                       Contro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229CD1-20D7-42DA-5C31-D285D6F8F560}"/>
              </a:ext>
            </a:extLst>
          </p:cNvPr>
          <p:cNvSpPr txBox="1"/>
          <p:nvPr/>
        </p:nvSpPr>
        <p:spPr>
          <a:xfrm>
            <a:off x="2897294" y="441948"/>
            <a:ext cx="914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AR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798BCF0-0843-51EE-BFE2-C08DB7F5410D}"/>
              </a:ext>
            </a:extLst>
          </p:cNvPr>
          <p:cNvSpPr txBox="1"/>
          <p:nvPr/>
        </p:nvSpPr>
        <p:spPr>
          <a:xfrm>
            <a:off x="2821094" y="2252513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BD34F6C-CF2A-B34F-604C-3DA2BBA30D68}"/>
              </a:ext>
            </a:extLst>
          </p:cNvPr>
          <p:cNvSpPr txBox="1"/>
          <p:nvPr/>
        </p:nvSpPr>
        <p:spPr>
          <a:xfrm>
            <a:off x="958645" y="2603662"/>
            <a:ext cx="2286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hite Tray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0AFB1C-7C5B-8551-FE27-BFF598F17D84}"/>
              </a:ext>
            </a:extLst>
          </p:cNvPr>
          <p:cNvSpPr txBox="1"/>
          <p:nvPr/>
        </p:nvSpPr>
        <p:spPr>
          <a:xfrm>
            <a:off x="8566587" y="2603662"/>
            <a:ext cx="1905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lack Tray </a:t>
            </a:r>
          </a:p>
        </p:txBody>
      </p:sp>
      <p:pic>
        <p:nvPicPr>
          <p:cNvPr id="14" name="Picture 2" descr="E:\My courses\Thesis\Western Blot\Lina W C1.png">
            <a:extLst>
              <a:ext uri="{FF2B5EF4-FFF2-40B4-BE49-F238E27FC236}">
                <a16:creationId xmlns:a16="http://schemas.microsoft.com/office/drawing/2014/main" id="{57FC9E38-D533-ED3B-628D-C4031D7D65B2}"/>
              </a:ext>
            </a:extLst>
          </p:cNvPr>
          <p:cNvPicPr>
            <a:picLocks noGrp="1" noChangeAspect="1" noChangeArrowheads="1"/>
          </p:cNvPicPr>
          <p:nvPr>
            <p:ph idx="1"/>
          </p:nvPr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13" t="49883" r="56666" b="43546"/>
          <a:stretch/>
        </p:blipFill>
        <p:spPr bwMode="auto">
          <a:xfrm>
            <a:off x="-19664" y="5109515"/>
            <a:ext cx="3702756" cy="99974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3">
            <a:extLst>
              <a:ext uri="{FF2B5EF4-FFF2-40B4-BE49-F238E27FC236}">
                <a16:creationId xmlns:a16="http://schemas.microsoft.com/office/drawing/2014/main" id="{DC388665-3798-87A9-45C4-42994D95E6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140"/>
          <a:stretch/>
        </p:blipFill>
        <p:spPr bwMode="auto">
          <a:xfrm>
            <a:off x="56536" y="3166823"/>
            <a:ext cx="3581400" cy="17520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83C1EC34-8FD6-5490-E91D-E533273D9F92}"/>
              </a:ext>
            </a:extLst>
          </p:cNvPr>
          <p:cNvSpPr/>
          <p:nvPr/>
        </p:nvSpPr>
        <p:spPr>
          <a:xfrm>
            <a:off x="132736" y="2880050"/>
            <a:ext cx="35052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Treated                       Control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B2D3E9F5-ED7B-B216-B809-EA11828CA3FD}"/>
              </a:ext>
            </a:extLst>
          </p:cNvPr>
          <p:cNvSpPr/>
          <p:nvPr/>
        </p:nvSpPr>
        <p:spPr>
          <a:xfrm>
            <a:off x="6486319" y="3327919"/>
            <a:ext cx="85151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116 KD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9DC5F8A9-9284-3A6E-9C04-A1A6AC55BE1C}"/>
              </a:ext>
            </a:extLst>
          </p:cNvPr>
          <p:cNvSpPr/>
          <p:nvPr/>
        </p:nvSpPr>
        <p:spPr>
          <a:xfrm>
            <a:off x="6486319" y="4438955"/>
            <a:ext cx="7344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89 KD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EEDCA58-5D98-D6A2-6284-9311D285BA89}"/>
              </a:ext>
            </a:extLst>
          </p:cNvPr>
          <p:cNvSpPr/>
          <p:nvPr/>
        </p:nvSpPr>
        <p:spPr>
          <a:xfrm>
            <a:off x="6486319" y="5338115"/>
            <a:ext cx="7344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35 KD</a:t>
            </a:r>
          </a:p>
        </p:txBody>
      </p:sp>
      <p:pic>
        <p:nvPicPr>
          <p:cNvPr id="20" name="Picture 4" descr="E:\My courses\Thesis\Western Blot\Lina Western 5 (2).png">
            <a:extLst>
              <a:ext uri="{FF2B5EF4-FFF2-40B4-BE49-F238E27FC236}">
                <a16:creationId xmlns:a16="http://schemas.microsoft.com/office/drawing/2014/main" id="{8965DFA9-95BB-E78A-942A-EE1B078C143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53" b="23033"/>
          <a:stretch/>
        </p:blipFill>
        <p:spPr bwMode="auto">
          <a:xfrm>
            <a:off x="7337834" y="3204817"/>
            <a:ext cx="3693920" cy="16760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5">
            <a:extLst>
              <a:ext uri="{FF2B5EF4-FFF2-40B4-BE49-F238E27FC236}">
                <a16:creationId xmlns:a16="http://schemas.microsoft.com/office/drawing/2014/main" id="{6722D14F-2792-88DB-41A7-4F1DD94F040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57" t="9654" r="-8157" b="40346"/>
          <a:stretch/>
        </p:blipFill>
        <p:spPr bwMode="auto">
          <a:xfrm>
            <a:off x="7220815" y="5073463"/>
            <a:ext cx="4187063" cy="8894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F5DA3AB5-CDEB-EEE1-5575-65A3EE8D57D1}"/>
              </a:ext>
            </a:extLst>
          </p:cNvPr>
          <p:cNvSpPr txBox="1"/>
          <p:nvPr/>
        </p:nvSpPr>
        <p:spPr>
          <a:xfrm>
            <a:off x="3016742" y="0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63D163F-0AEB-E63C-3892-00B29950C11E}"/>
              </a:ext>
            </a:extLst>
          </p:cNvPr>
          <p:cNvSpPr txBox="1"/>
          <p:nvPr/>
        </p:nvSpPr>
        <p:spPr>
          <a:xfrm>
            <a:off x="56536" y="2566476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95D8D08-8121-C273-3007-E89EF08DE0E5}"/>
              </a:ext>
            </a:extLst>
          </p:cNvPr>
          <p:cNvSpPr txBox="1"/>
          <p:nvPr/>
        </p:nvSpPr>
        <p:spPr>
          <a:xfrm>
            <a:off x="7781471" y="2566476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</a:t>
            </a:r>
            <a:r>
              <a:rPr lang="en-US" dirty="0">
                <a:solidFill>
                  <a:prstClr val="black"/>
                </a:solidFill>
                <a:latin typeface="Calibri" panose="020F0502020204030204"/>
              </a:rPr>
              <a:t>C</a:t>
            </a: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966253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greyscale shot of a rectangular object&#10;&#10;Description automatically generated">
            <a:extLst>
              <a:ext uri="{FF2B5EF4-FFF2-40B4-BE49-F238E27FC236}">
                <a16:creationId xmlns:a16="http://schemas.microsoft.com/office/drawing/2014/main" id="{0620591F-C8A0-FBC4-CF3F-5E2A454F9F1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39" r="15339"/>
          <a:stretch/>
        </p:blipFill>
        <p:spPr>
          <a:xfrm>
            <a:off x="239486" y="1690688"/>
            <a:ext cx="7598230" cy="5135563"/>
          </a:xfrm>
        </p:spPr>
      </p:pic>
      <p:pic>
        <p:nvPicPr>
          <p:cNvPr id="6" name="Picture 2">
            <a:extLst>
              <a:ext uri="{FF2B5EF4-FFF2-40B4-BE49-F238E27FC236}">
                <a16:creationId xmlns:a16="http://schemas.microsoft.com/office/drawing/2014/main" id="{39FEE60C-7E9B-6351-CE5B-8B2DF6E81A1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23" t="14061" r="40492" b="24345"/>
          <a:stretch/>
        </p:blipFill>
        <p:spPr bwMode="auto">
          <a:xfrm>
            <a:off x="7990113" y="1926768"/>
            <a:ext cx="4156227" cy="40410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74DBAEB-0050-3DE1-52A2-7AB263626A70}"/>
              </a:ext>
            </a:extLst>
          </p:cNvPr>
          <p:cNvSpPr txBox="1"/>
          <p:nvPr/>
        </p:nvSpPr>
        <p:spPr>
          <a:xfrm>
            <a:off x="7707083" y="1633674"/>
            <a:ext cx="47461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           ladder -RT  +RT </a:t>
            </a:r>
            <a:r>
              <a:rPr lang="en-US" sz="1100" dirty="0"/>
              <a:t>old CDNA  </a:t>
            </a:r>
            <a:r>
              <a:rPr lang="en-US" sz="1600" dirty="0"/>
              <a:t>N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E10C9DA-9CED-9FC1-441B-F102E56DF66E}"/>
              </a:ext>
            </a:extLst>
          </p:cNvPr>
          <p:cNvSpPr txBox="1"/>
          <p:nvPr/>
        </p:nvSpPr>
        <p:spPr>
          <a:xfrm rot="18815474">
            <a:off x="1003324" y="646614"/>
            <a:ext cx="24513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KI67 –RT Samp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3EE997-AFA2-1066-7CFE-3D95A6CB5B52}"/>
              </a:ext>
            </a:extLst>
          </p:cNvPr>
          <p:cNvSpPr txBox="1"/>
          <p:nvPr/>
        </p:nvSpPr>
        <p:spPr>
          <a:xfrm rot="18815474">
            <a:off x="1335667" y="651883"/>
            <a:ext cx="2460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KI67 +RT Samp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EC7D2A5-7A7D-93E3-E1F6-CC785B5EBED7}"/>
              </a:ext>
            </a:extLst>
          </p:cNvPr>
          <p:cNvSpPr txBox="1"/>
          <p:nvPr/>
        </p:nvSpPr>
        <p:spPr>
          <a:xfrm rot="18815474">
            <a:off x="1573258" y="594540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25 treated KI67 –RT Sample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7F4292A-CB63-2BD6-128E-1C467ECECE81}"/>
              </a:ext>
            </a:extLst>
          </p:cNvPr>
          <p:cNvSpPr txBox="1"/>
          <p:nvPr/>
        </p:nvSpPr>
        <p:spPr>
          <a:xfrm rot="18815474">
            <a:off x="834655" y="1003126"/>
            <a:ext cx="1477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Ladd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A61548B-001E-7221-4388-4567EAAFA522}"/>
              </a:ext>
            </a:extLst>
          </p:cNvPr>
          <p:cNvSpPr txBox="1"/>
          <p:nvPr/>
        </p:nvSpPr>
        <p:spPr>
          <a:xfrm rot="18815474">
            <a:off x="1914454" y="567981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25 treated KI67 +RT Sample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B9443F-24C2-5175-CBD3-F885311E2757}"/>
              </a:ext>
            </a:extLst>
          </p:cNvPr>
          <p:cNvSpPr txBox="1"/>
          <p:nvPr/>
        </p:nvSpPr>
        <p:spPr>
          <a:xfrm rot="18815474">
            <a:off x="2207982" y="579098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50 treated KI67 –RT Sample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78DBCBA-D0B3-46A3-80DC-2415E3BF3E49}"/>
              </a:ext>
            </a:extLst>
          </p:cNvPr>
          <p:cNvSpPr txBox="1"/>
          <p:nvPr/>
        </p:nvSpPr>
        <p:spPr>
          <a:xfrm rot="18815474">
            <a:off x="2559010" y="572203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50 treated KI67 +RT Sample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EAEA28A-897D-FACE-0068-4EE85A392D98}"/>
              </a:ext>
            </a:extLst>
          </p:cNvPr>
          <p:cNvSpPr txBox="1"/>
          <p:nvPr/>
        </p:nvSpPr>
        <p:spPr>
          <a:xfrm rot="18815474">
            <a:off x="4665839" y="684406"/>
            <a:ext cx="24513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</a:t>
            </a:r>
            <a:r>
              <a:rPr lang="en-US" sz="1400" i="1" dirty="0" err="1"/>
              <a:t>Survivin</a:t>
            </a:r>
            <a:r>
              <a:rPr lang="en-US" sz="1400" i="1" dirty="0"/>
              <a:t> +RT Sample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7C8A4A5-744A-DEFA-9F2B-B2FF8299146C}"/>
              </a:ext>
            </a:extLst>
          </p:cNvPr>
          <p:cNvSpPr txBox="1"/>
          <p:nvPr/>
        </p:nvSpPr>
        <p:spPr>
          <a:xfrm rot="18815474">
            <a:off x="4994633" y="681114"/>
            <a:ext cx="24604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Untreated </a:t>
            </a:r>
            <a:r>
              <a:rPr lang="en-US" sz="1400" i="1" dirty="0" err="1"/>
              <a:t>Survivin</a:t>
            </a:r>
            <a:r>
              <a:rPr lang="en-US" sz="1400" i="1" dirty="0"/>
              <a:t> -RT Sample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ED761A4-38DA-7667-A585-0486B7EEC544}"/>
              </a:ext>
            </a:extLst>
          </p:cNvPr>
          <p:cNvSpPr txBox="1"/>
          <p:nvPr/>
        </p:nvSpPr>
        <p:spPr>
          <a:xfrm rot="18815474">
            <a:off x="5304176" y="601434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25 treated </a:t>
            </a:r>
            <a:r>
              <a:rPr lang="en-US" sz="1400" i="1" dirty="0" err="1"/>
              <a:t>Survivin</a:t>
            </a:r>
            <a:r>
              <a:rPr lang="en-US" sz="1400" i="1" dirty="0"/>
              <a:t> +RT Sample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0558C08-4C88-85CD-60FD-CB6C00B80D04}"/>
              </a:ext>
            </a:extLst>
          </p:cNvPr>
          <p:cNvSpPr txBox="1"/>
          <p:nvPr/>
        </p:nvSpPr>
        <p:spPr>
          <a:xfrm rot="18815474">
            <a:off x="5645372" y="574875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25 treated </a:t>
            </a:r>
            <a:r>
              <a:rPr lang="en-US" sz="1400" i="1" dirty="0" err="1"/>
              <a:t>Survivin</a:t>
            </a:r>
            <a:r>
              <a:rPr lang="en-US" sz="1400" i="1" dirty="0"/>
              <a:t> -RT Sample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B68BAD8-A77C-8202-524C-ADC7D22EC72E}"/>
              </a:ext>
            </a:extLst>
          </p:cNvPr>
          <p:cNvSpPr txBox="1"/>
          <p:nvPr/>
        </p:nvSpPr>
        <p:spPr>
          <a:xfrm rot="18815474">
            <a:off x="5968396" y="585992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50 treated </a:t>
            </a:r>
            <a:r>
              <a:rPr lang="en-US" sz="1400" i="1" dirty="0" err="1"/>
              <a:t>Survivin</a:t>
            </a:r>
            <a:r>
              <a:rPr lang="en-US" sz="1400" i="1" dirty="0"/>
              <a:t> +RT Sample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C921130-C2B4-16D9-52F9-D44DA94A52E9}"/>
              </a:ext>
            </a:extLst>
          </p:cNvPr>
          <p:cNvSpPr txBox="1"/>
          <p:nvPr/>
        </p:nvSpPr>
        <p:spPr>
          <a:xfrm rot="18815474">
            <a:off x="6329256" y="579097"/>
            <a:ext cx="27347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IC50 treated </a:t>
            </a:r>
            <a:r>
              <a:rPr lang="en-US" sz="1400" i="1" dirty="0" err="1"/>
              <a:t>Survivin</a:t>
            </a:r>
            <a:r>
              <a:rPr lang="en-US" sz="1400" i="1" dirty="0"/>
              <a:t> -RT Sample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3C8B961-F094-010A-E051-D6AE3AF14EA5}"/>
              </a:ext>
            </a:extLst>
          </p:cNvPr>
          <p:cNvSpPr txBox="1"/>
          <p:nvPr/>
        </p:nvSpPr>
        <p:spPr>
          <a:xfrm>
            <a:off x="177110" y="1264615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BF612A9-A68E-C8EB-1269-FD74A6930505}"/>
              </a:ext>
            </a:extLst>
          </p:cNvPr>
          <p:cNvSpPr txBox="1"/>
          <p:nvPr/>
        </p:nvSpPr>
        <p:spPr>
          <a:xfrm>
            <a:off x="7821161" y="1157014"/>
            <a:ext cx="691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55820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</TotalTime>
  <Words>645</Words>
  <Application>Microsoft Office PowerPoint</Application>
  <PresentationFormat>Widescreen</PresentationFormat>
  <Paragraphs>77</Paragraphs>
  <Slides>7</Slides>
  <Notes>7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haledAbdelRaouf</dc:creator>
  <cp:lastModifiedBy>KhaledAbdelRaouf</cp:lastModifiedBy>
  <cp:revision>5</cp:revision>
  <dcterms:created xsi:type="dcterms:W3CDTF">2023-05-20T18:42:54Z</dcterms:created>
  <dcterms:modified xsi:type="dcterms:W3CDTF">2023-12-01T00:35:55Z</dcterms:modified>
</cp:coreProperties>
</file>